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144000" type="letter"/>
  <p:notesSz cx="6950075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382" autoAdjust="0"/>
    <p:restoredTop sz="94660"/>
  </p:normalViewPr>
  <p:slideViewPr>
    <p:cSldViewPr snapToGrid="0">
      <p:cViewPr varScale="1">
        <p:scale>
          <a:sx n="91" d="100"/>
          <a:sy n="91" d="100"/>
        </p:scale>
        <p:origin x="287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039198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91584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60612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0490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48763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56051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72645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19371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177802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85241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20805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3012BF-15E9-4F38-AD73-E2B4F0A0BE78}" type="datetimeFigureOut">
              <a:rPr lang="en-US" smtClean="0"/>
              <a:t>6/1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6C8A6F-9B8E-4B16-8B07-2367FB8A21E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362315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"/>
          <p:cNvSpPr txBox="1"/>
          <p:nvPr/>
        </p:nvSpPr>
        <p:spPr>
          <a:xfrm>
            <a:off x="0" y="7942097"/>
            <a:ext cx="647004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Helvetica" pitchFamily="2" charset="0"/>
              </a:rPr>
              <a:t>Supplemental Figure 4. </a:t>
            </a:r>
            <a:r>
              <a:rPr lang="en-US" sz="1200" dirty="0">
                <a:latin typeface="Helvetica" pitchFamily="2" charset="0"/>
              </a:rPr>
              <a:t>Landmark analysis of the MedStar-Georgetown University Hospital </a:t>
            </a:r>
          </a:p>
          <a:p>
            <a:r>
              <a:rPr lang="en-US" sz="1200" dirty="0">
                <a:latin typeface="Helvetica" pitchFamily="2" charset="0"/>
              </a:rPr>
              <a:t>Database (Georgetown cohort).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9421"/>
            <a:ext cx="3328440" cy="237745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745945"/>
            <a:ext cx="3328440" cy="237745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9560" y="2745945"/>
            <a:ext cx="3328440" cy="237745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9560" y="5489144"/>
            <a:ext cx="3328440" cy="237745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489144"/>
            <a:ext cx="3328440" cy="2377457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93738"/>
            <a:ext cx="3328440" cy="23774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19688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7</TotalTime>
  <Words>16</Words>
  <Application>Microsoft Office PowerPoint</Application>
  <PresentationFormat>Letter Paper (8.5x11 in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szik,Jason</dc:creator>
  <cp:lastModifiedBy>Liu, Xi (NIH/NCI) [C]</cp:lastModifiedBy>
  <cp:revision>45</cp:revision>
  <cp:lastPrinted>2020-01-22T18:02:35Z</cp:lastPrinted>
  <dcterms:created xsi:type="dcterms:W3CDTF">2020-01-16T15:49:54Z</dcterms:created>
  <dcterms:modified xsi:type="dcterms:W3CDTF">2022-06-13T20:44:21Z</dcterms:modified>
</cp:coreProperties>
</file>